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33CC33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62" autoAdjust="0"/>
    <p:restoredTop sz="94662" autoAdjust="0"/>
  </p:normalViewPr>
  <p:slideViewPr>
    <p:cSldViewPr snapToObjects="1">
      <p:cViewPr varScale="1">
        <p:scale>
          <a:sx n="183" d="100"/>
          <a:sy n="183" d="100"/>
        </p:scale>
        <p:origin x="-156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38405" cy="384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00FA25-2540-480C-BF0C-111CA0472978}" type="datetimeFigureOut">
              <a:rPr lang="en-US" smtClean="0"/>
              <a:t>7/17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76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16427"/>
            <a:ext cx="55054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75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0B9004-DADF-49A1-AA19-266F797772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7070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471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745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073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167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30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635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517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386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637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79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514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851EC-3F21-4029-B01F-DC69F91119F2}" type="datetimeFigureOut">
              <a:rPr lang="en-US" smtClean="0"/>
              <a:t>7/17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7D337-8DDF-4D3E-89FB-D833F0C17F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497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375835" y="425246"/>
            <a:ext cx="19488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1a)  HIV-1Tg_Nicotine  PFC</a:t>
            </a:r>
            <a:endParaRPr 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880342" y="386841"/>
            <a:ext cx="17235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smtClean="0"/>
              <a:t>S1b) </a:t>
            </a:r>
            <a:r>
              <a:rPr lang="en-US" sz="1200" b="1" dirty="0" smtClean="0"/>
              <a:t>F344_Nicotine  PFC</a:t>
            </a:r>
            <a:endParaRPr lang="en-US" sz="1200" b="1" dirty="0"/>
          </a:p>
        </p:txBody>
      </p:sp>
      <p:pic>
        <p:nvPicPr>
          <p:cNvPr id="9" name="Picture 7" descr="C:\Users\tn2u\Desktop\IPA3-3-15-editing MS figures\HN-PFC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1" t="3080" r="3128" b="3131"/>
          <a:stretch/>
        </p:blipFill>
        <p:spPr bwMode="auto">
          <a:xfrm>
            <a:off x="206225" y="764494"/>
            <a:ext cx="4347693" cy="45551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0" descr="C:\Users\tn2u\Desktop\IPA3-3-15-editing MS figures\FN-PFC.jpg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5" t="3081" r="3722" b="3294"/>
          <a:stretch/>
        </p:blipFill>
        <p:spPr bwMode="auto">
          <a:xfrm>
            <a:off x="4648810" y="748451"/>
            <a:ext cx="4416575" cy="45688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4" name="Group 13"/>
          <p:cNvGrpSpPr/>
          <p:nvPr/>
        </p:nvGrpSpPr>
        <p:grpSpPr>
          <a:xfrm>
            <a:off x="903335" y="5579680"/>
            <a:ext cx="8008430" cy="560204"/>
            <a:chOff x="558452" y="2031410"/>
            <a:chExt cx="7274452" cy="560204"/>
          </a:xfrm>
        </p:grpSpPr>
        <p:grpSp>
          <p:nvGrpSpPr>
            <p:cNvPr id="15" name="Group 14"/>
            <p:cNvGrpSpPr/>
            <p:nvPr/>
          </p:nvGrpSpPr>
          <p:grpSpPr>
            <a:xfrm>
              <a:off x="558452" y="2031410"/>
              <a:ext cx="2052801" cy="276999"/>
              <a:chOff x="1192360" y="3697835"/>
              <a:chExt cx="2768046" cy="276999"/>
            </a:xfrm>
          </p:grpSpPr>
          <p:sp>
            <p:nvSpPr>
              <p:cNvPr id="28" name="Oval 27"/>
              <p:cNvSpPr/>
              <p:nvPr/>
            </p:nvSpPr>
            <p:spPr>
              <a:xfrm>
                <a:off x="1192360" y="3774645"/>
                <a:ext cx="171979" cy="153620"/>
              </a:xfrm>
              <a:prstGeom prst="ellipse">
                <a:avLst/>
              </a:prstGeom>
              <a:solidFill>
                <a:srgbClr val="CCFFCC"/>
              </a:solidFill>
              <a:ln>
                <a:solidFill>
                  <a:srgbClr val="CCFFC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1398530" y="3697835"/>
                <a:ext cx="25618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Down-regulated (FC &lt; 0.90)</a:t>
                </a:r>
                <a:endParaRPr lang="en-US" sz="1200" dirty="0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558452" y="2314615"/>
              <a:ext cx="2589757" cy="276999"/>
              <a:chOff x="1192360" y="3697835"/>
              <a:chExt cx="3492091" cy="276999"/>
            </a:xfrm>
          </p:grpSpPr>
          <p:sp>
            <p:nvSpPr>
              <p:cNvPr id="26" name="Oval 25"/>
              <p:cNvSpPr/>
              <p:nvPr/>
            </p:nvSpPr>
            <p:spPr>
              <a:xfrm>
                <a:off x="1192360" y="3774645"/>
                <a:ext cx="171979" cy="153620"/>
              </a:xfrm>
              <a:prstGeom prst="ellipse">
                <a:avLst/>
              </a:prstGeom>
              <a:solidFill>
                <a:srgbClr val="CCFFCC"/>
              </a:solidFill>
              <a:ln w="9525">
                <a:solidFill>
                  <a:srgbClr val="33CC33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398530" y="3697835"/>
                <a:ext cx="32859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Down-regulated (FC &lt; 0.90, P &lt;0.05)</a:t>
                </a:r>
                <a:endParaRPr lang="en-US" sz="1200" dirty="0"/>
              </a:p>
            </p:txBody>
          </p:sp>
        </p:grpSp>
        <p:grpSp>
          <p:nvGrpSpPr>
            <p:cNvPr id="17" name="Group 16"/>
            <p:cNvGrpSpPr/>
            <p:nvPr/>
          </p:nvGrpSpPr>
          <p:grpSpPr>
            <a:xfrm>
              <a:off x="2932952" y="2037209"/>
              <a:ext cx="1752914" cy="276999"/>
              <a:chOff x="1192360" y="3697835"/>
              <a:chExt cx="2363670" cy="276999"/>
            </a:xfrm>
          </p:grpSpPr>
          <p:sp>
            <p:nvSpPr>
              <p:cNvPr id="24" name="Oval 23"/>
              <p:cNvSpPr/>
              <p:nvPr/>
            </p:nvSpPr>
            <p:spPr>
              <a:xfrm>
                <a:off x="1192360" y="3774645"/>
                <a:ext cx="171979" cy="153620"/>
              </a:xfrm>
              <a:prstGeom prst="ellipse">
                <a:avLst/>
              </a:prstGeom>
              <a:solidFill>
                <a:srgbClr val="FF7C80"/>
              </a:solidFill>
              <a:ln>
                <a:solidFill>
                  <a:srgbClr val="FF7C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398530" y="3697835"/>
                <a:ext cx="215750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Up-regulated (FC &gt;1.1)</a:t>
                </a:r>
                <a:endParaRPr lang="en-US" sz="1200" dirty="0"/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2932952" y="2298819"/>
              <a:ext cx="2359451" cy="276999"/>
              <a:chOff x="1192360" y="3697835"/>
              <a:chExt cx="3181540" cy="276999"/>
            </a:xfrm>
          </p:grpSpPr>
          <p:sp>
            <p:nvSpPr>
              <p:cNvPr id="22" name="Oval 21"/>
              <p:cNvSpPr/>
              <p:nvPr/>
            </p:nvSpPr>
            <p:spPr>
              <a:xfrm>
                <a:off x="1192360" y="3774645"/>
                <a:ext cx="171979" cy="153620"/>
              </a:xfrm>
              <a:prstGeom prst="ellipse">
                <a:avLst/>
              </a:prstGeom>
              <a:solidFill>
                <a:srgbClr val="FF7C80"/>
              </a:solidFill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398530" y="3697835"/>
                <a:ext cx="29753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Up-regulated (FC &gt; 1.1, P &lt; 0.05)</a:t>
                </a:r>
                <a:endParaRPr lang="en-US" sz="1200" dirty="0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4879240" y="2034893"/>
              <a:ext cx="2953664" cy="276999"/>
              <a:chOff x="1192360" y="3697835"/>
              <a:chExt cx="3982791" cy="276999"/>
            </a:xfrm>
          </p:grpSpPr>
          <p:sp>
            <p:nvSpPr>
              <p:cNvPr id="20" name="Oval 19"/>
              <p:cNvSpPr/>
              <p:nvPr/>
            </p:nvSpPr>
            <p:spPr>
              <a:xfrm>
                <a:off x="1192360" y="3774645"/>
                <a:ext cx="171979" cy="153620"/>
              </a:xfrm>
              <a:prstGeom prst="ellipse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398530" y="3697835"/>
                <a:ext cx="37766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No regulation or did not include the assay</a:t>
                </a:r>
                <a:endParaRPr lang="en-US" sz="1200" dirty="0"/>
              </a:p>
            </p:txBody>
          </p:sp>
        </p:grpSp>
      </p:grpSp>
      <p:sp>
        <p:nvSpPr>
          <p:cNvPr id="2" name="Rectangle 1"/>
          <p:cNvSpPr/>
          <p:nvPr/>
        </p:nvSpPr>
        <p:spPr>
          <a:xfrm>
            <a:off x="7229397" y="6309375"/>
            <a:ext cx="16971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 smtClean="0"/>
              <a:t>Additional Fil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36494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7</TotalTime>
  <Words>61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sil, Tanseli (tn2u)</dc:creator>
  <cp:lastModifiedBy>Ming Li</cp:lastModifiedBy>
  <cp:revision>98</cp:revision>
  <cp:lastPrinted>2015-03-23T21:00:14Z</cp:lastPrinted>
  <dcterms:created xsi:type="dcterms:W3CDTF">2014-11-12T16:22:34Z</dcterms:created>
  <dcterms:modified xsi:type="dcterms:W3CDTF">2015-07-17T18:19:44Z</dcterms:modified>
</cp:coreProperties>
</file>